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4" autoAdjust="0"/>
    <p:restoredTop sz="94660"/>
  </p:normalViewPr>
  <p:slideViewPr>
    <p:cSldViewPr snapToGrid="0" showGuides="1">
      <p:cViewPr varScale="1">
        <p:scale>
          <a:sx n="128" d="100"/>
          <a:sy n="128" d="100"/>
        </p:scale>
        <p:origin x="520" y="1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7EC6286-F409-E2CE-9E4D-F17E00E4269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15F5BFEF-6356-1644-4A5A-2DCBAE09928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CFA8226-99E7-A9EC-BFC7-95F5C8BC2F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6E5A7-B8B8-4684-974A-32BCF6EF0E5E}" type="datetimeFigureOut">
              <a:rPr lang="en-US" smtClean="0"/>
              <a:t>5/12/22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6CF0125-8F94-C0C7-CF96-B8706C082F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83C1518-3E0B-EF97-9CC9-34D0C67635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4ECF8C-744E-4CA3-A28F-61DA8A247B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65816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3FAF493-4927-2421-5C82-D3252E740A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477804A1-1A5B-BE5E-F876-329C5A67F3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5E73160-208F-A5ED-3736-58247C8018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6E5A7-B8B8-4684-974A-32BCF6EF0E5E}" type="datetimeFigureOut">
              <a:rPr lang="en-US" smtClean="0"/>
              <a:t>5/12/22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B9BF014-DDAB-875C-24E1-5B5AB0876F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9D7C485-7BC5-5736-6716-99DB66D9F6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4ECF8C-744E-4CA3-A28F-61DA8A247B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3742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F8DD5A33-3E16-5463-CA9F-C1DEC83D902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E4678786-A663-5A81-C716-4A96BD4C042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9993377-7761-C6B4-50F4-7D088ED8D2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6E5A7-B8B8-4684-974A-32BCF6EF0E5E}" type="datetimeFigureOut">
              <a:rPr lang="en-US" smtClean="0"/>
              <a:t>5/12/22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D454293-C2BB-065E-9ADD-7A061C5B05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43DE664-D98A-FE49-BBED-65695B9E3E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4ECF8C-744E-4CA3-A28F-61DA8A247B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77480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3CA04CC-430A-82FB-A429-2099CFC94E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4A239F39-36EA-0540-85B1-A46137567E8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CE674ED-7821-D575-36C1-B46FDC9BE2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6E5A7-B8B8-4684-974A-32BCF6EF0E5E}" type="datetimeFigureOut">
              <a:rPr lang="en-US" smtClean="0"/>
              <a:t>5/12/22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1F56F14-564B-F21D-11F8-5E7336C38B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79CDEAE-A5DE-4E69-8EC3-9EFB21A74F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4ECF8C-744E-4CA3-A28F-61DA8A247B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65771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33D566B-F9DA-A2BB-F2CA-B837723A80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55836D26-47C5-CDCA-3918-9CBCD5B5BE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6EBA715-C29E-D7C7-5D7E-26520B1F7B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6E5A7-B8B8-4684-974A-32BCF6EF0E5E}" type="datetimeFigureOut">
              <a:rPr lang="en-US" smtClean="0"/>
              <a:t>5/12/22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209F027-00D6-F91B-49A5-A80DE3DC64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3D80768-E857-06DA-80B3-5AB59C3568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4ECF8C-744E-4CA3-A28F-61DA8A247B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64360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126273E-C23D-1E88-5F2F-14D3339B62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BDC6D481-55D4-5601-9220-75C71988FCE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D62A6A16-9818-12BF-72A7-D982470D49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73D7F9D8-8672-F28A-C58C-001E5AC9FB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6E5A7-B8B8-4684-974A-32BCF6EF0E5E}" type="datetimeFigureOut">
              <a:rPr lang="en-US" smtClean="0"/>
              <a:t>5/12/22</a:t>
            </a:fld>
            <a:endParaRPr lang="en-U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79F4ECE1-87EE-55B4-4280-25935010E6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2F895C7A-2DD9-98B6-04A8-52FA7F698D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4ECF8C-744E-4CA3-A28F-61DA8A247B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38919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393DD23-5126-6B0E-3F34-E10CF108C8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AEFB45B2-62A8-EDF0-F508-C36F3F1791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9435D608-CD0F-CA06-CF83-CEEF063A080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B90CF7FF-1DB7-8D7E-6A3E-3FB3B72F0A5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23CBAB0F-946C-22D7-A240-42CF47EC7F4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CAE19DE1-6E8A-72D7-A279-8469F60B46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6E5A7-B8B8-4684-974A-32BCF6EF0E5E}" type="datetimeFigureOut">
              <a:rPr lang="en-US" smtClean="0"/>
              <a:t>5/12/22</a:t>
            </a:fld>
            <a:endParaRPr lang="en-U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922E83CE-A986-D8AC-DEFF-9E56BDC133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4E8194C8-4750-DAAE-C2E2-8BAC69F4E3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4ECF8C-744E-4CA3-A28F-61DA8A247B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2823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0FE31B9-B900-B291-7550-2FD68C1085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F9C8FB39-1348-92ED-8F82-71B13A9CDB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6E5A7-B8B8-4684-974A-32BCF6EF0E5E}" type="datetimeFigureOut">
              <a:rPr lang="en-US" smtClean="0"/>
              <a:t>5/12/22</a:t>
            </a:fld>
            <a:endParaRPr lang="en-U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4A4B0556-2562-2AE4-3A52-FE292AF55F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C53EAA7A-C5C3-ACEF-1664-C114382CC8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4ECF8C-744E-4CA3-A28F-61DA8A247B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74945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2715B463-CD18-D773-CBD3-AA1F7568D6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6E5A7-B8B8-4684-974A-32BCF6EF0E5E}" type="datetimeFigureOut">
              <a:rPr lang="en-US" smtClean="0"/>
              <a:t>5/12/22</a:t>
            </a:fld>
            <a:endParaRPr lang="en-U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F6C9E424-04FC-6F07-4AE5-588D10E623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C3755426-DA43-67DE-56AC-E0CBE9AA97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4ECF8C-744E-4CA3-A28F-61DA8A247B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25529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8BDE0D3-1139-AC1B-B980-E2346E1A83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F3B2F416-99DC-3A3F-189A-1A2F3613B03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476E6978-AD70-13AD-C506-6B0E98A133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268C2757-819A-6C45-8874-1DD99D3D88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6E5A7-B8B8-4684-974A-32BCF6EF0E5E}" type="datetimeFigureOut">
              <a:rPr lang="en-US" smtClean="0"/>
              <a:t>5/12/22</a:t>
            </a:fld>
            <a:endParaRPr lang="en-U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22522C24-A2C1-20C9-A472-7A9AB5C939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C951A32E-AF97-B782-1A0D-BEC7596D53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4ECF8C-744E-4CA3-A28F-61DA8A247B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1417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84B9FE1-449E-95B8-D367-F1FD677BCE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1E7571BF-C5BD-F979-EC46-AE502185830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E8A7FA72-B1FA-22DB-ED52-313E556ECD3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7D6A3A2D-00B7-A996-E87D-4EAA21BAF1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6E5A7-B8B8-4684-974A-32BCF6EF0E5E}" type="datetimeFigureOut">
              <a:rPr lang="en-US" smtClean="0"/>
              <a:t>5/12/22</a:t>
            </a:fld>
            <a:endParaRPr lang="en-U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41FAA9EE-3238-C6FC-5F93-54C2CC217B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A86536EE-73B2-090C-96E5-04F1377C9E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4ECF8C-744E-4CA3-A28F-61DA8A247B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85596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DEDFCE1F-E2A7-9D81-CF73-27EA1C975B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1BAAFD6D-05C3-CB9E-221E-1AD199E472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ECE4071-B62B-27AE-16FB-73D02C78FBA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46E5A7-B8B8-4684-974A-32BCF6EF0E5E}" type="datetimeFigureOut">
              <a:rPr lang="en-US" smtClean="0"/>
              <a:t>5/12/22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36E0744-6DFA-2A10-EB12-AF11122E286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97BCC65-6E4C-7656-69DF-7AF3A1B4D59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4ECF8C-744E-4CA3-A28F-61DA8A247B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43088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>
            <a:extLst>
              <a:ext uri="{FF2B5EF4-FFF2-40B4-BE49-F238E27FC236}">
                <a16:creationId xmlns:a16="http://schemas.microsoft.com/office/drawing/2014/main" id="{B2496C3C-5E84-CCC7-7F8D-C1200337935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584" t="20303" b="39140"/>
          <a:stretch/>
        </p:blipFill>
        <p:spPr>
          <a:xfrm>
            <a:off x="3129498" y="1133474"/>
            <a:ext cx="5062002" cy="2781301"/>
          </a:xfrm>
          <a:prstGeom prst="rect">
            <a:avLst/>
          </a:prstGeom>
        </p:spPr>
      </p:pic>
      <p:sp>
        <p:nvSpPr>
          <p:cNvPr id="4" name="AutoShape 2">
            <a:extLst>
              <a:ext uri="{FF2B5EF4-FFF2-40B4-BE49-F238E27FC236}">
                <a16:creationId xmlns:a16="http://schemas.microsoft.com/office/drawing/2014/main" id="{1FDACBCA-E934-948E-9FF6-FDBA1B697BCB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5943600" y="3276600"/>
            <a:ext cx="304800" cy="304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AA4074D1-0B7A-5FB1-6E85-D21F240FD7ED}"/>
              </a:ext>
            </a:extLst>
          </p:cNvPr>
          <p:cNvSpPr txBox="1"/>
          <p:nvPr/>
        </p:nvSpPr>
        <p:spPr>
          <a:xfrm>
            <a:off x="2828925" y="4331790"/>
            <a:ext cx="6096000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upplementary Figure S1. PCR Electrophoresis Gel. M: Molecular weight marker (100 bp). Samples </a:t>
            </a:r>
            <a:r>
              <a:rPr lang="en-US" sz="11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1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to 9: positive for NDM. Line 10: positive control, Line 11: negative control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2BA0C20A-4DCB-1930-B133-642EA57F710D}"/>
              </a:ext>
            </a:extLst>
          </p:cNvPr>
          <p:cNvSpPr txBox="1"/>
          <p:nvPr/>
        </p:nvSpPr>
        <p:spPr>
          <a:xfrm>
            <a:off x="3239205" y="1326417"/>
            <a:ext cx="48684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>
                <a:solidFill>
                  <a:schemeClr val="bg1">
                    <a:lumMod val="9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M      1         2       3        4        5       6       7        8        9      10     11 </a:t>
            </a:r>
            <a:endParaRPr lang="en-US" sz="1200" dirty="0">
              <a:solidFill>
                <a:schemeClr val="bg1">
                  <a:lumMod val="9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3B22F8DD-671D-296B-6FF9-DA367A02DBBD}"/>
              </a:ext>
            </a:extLst>
          </p:cNvPr>
          <p:cNvSpPr txBox="1"/>
          <p:nvPr/>
        </p:nvSpPr>
        <p:spPr>
          <a:xfrm>
            <a:off x="2580113" y="2027068"/>
            <a:ext cx="635110" cy="1692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b="1" dirty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r>
              <a:rPr lang="es-MX" sz="1200" b="1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 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MX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s-MX" sz="1200" b="1" dirty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  <a:r>
              <a:rPr lang="es-MX" sz="1200" b="1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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s-MX" sz="12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r>
              <a:rPr lang="es-MX" sz="1200" b="1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 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CED0CFAD-ECD7-504F-D0C2-8B7D85F0C7C2}"/>
              </a:ext>
            </a:extLst>
          </p:cNvPr>
          <p:cNvSpPr txBox="1"/>
          <p:nvPr/>
        </p:nvSpPr>
        <p:spPr>
          <a:xfrm>
            <a:off x="8107654" y="1960393"/>
            <a:ext cx="59182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</a:t>
            </a:r>
            <a:r>
              <a:rPr lang="es-MX" sz="1200" dirty="0">
                <a:latin typeface="Arial" panose="020B0604020202020204" pitchFamily="34" charset="0"/>
                <a:cs typeface="Arial" panose="020B0604020202020204" pitchFamily="34" charset="0"/>
              </a:rPr>
              <a:t>678</a:t>
            </a:r>
          </a:p>
          <a:p>
            <a:endParaRPr lang="es-MX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MX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6031066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CDBBC957D690D41A117A590358041D8" ma:contentTypeVersion="4" ma:contentTypeDescription="Create a new document." ma:contentTypeScope="" ma:versionID="4e937571f4627807d472a6d781b62a41">
  <xsd:schema xmlns:xsd="http://www.w3.org/2001/XMLSchema" xmlns:xs="http://www.w3.org/2001/XMLSchema" xmlns:p="http://schemas.microsoft.com/office/2006/metadata/properties" xmlns:ns3="7926ff41-62f7-4eb9-adc7-e0a0a63dbcf6" targetNamespace="http://schemas.microsoft.com/office/2006/metadata/properties" ma:root="true" ma:fieldsID="c68cf2f4264c68c5d5260bfa44c63612" ns3:_="">
    <xsd:import namespace="7926ff41-62f7-4eb9-adc7-e0a0a63dbcf6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926ff41-62f7-4eb9-adc7-e0a0a63dbcf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E0D54699-ED1D-4DED-B671-6D6AEEF741D8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926ff41-62f7-4eb9-adc7-e0a0a63dbcf6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AAA351EA-A6FA-4BDD-A7CA-3752A4301E88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892A7C02-6CC7-4A19-AFAB-2992E06111AF}">
  <ds:schemaRefs>
    <ds:schemaRef ds:uri="http://schemas.microsoft.com/office/2006/documentManagement/types"/>
    <ds:schemaRef ds:uri="http://purl.org/dc/terms/"/>
    <ds:schemaRef ds:uri="http://purl.org/dc/elements/1.1/"/>
    <ds:schemaRef ds:uri="http://www.w3.org/XML/1998/namespace"/>
    <ds:schemaRef ds:uri="7926ff41-62f7-4eb9-adc7-e0a0a63dbcf6"/>
    <ds:schemaRef ds:uri="http://purl.org/dc/dcmitype/"/>
    <ds:schemaRef ds:uri="http://schemas.microsoft.com/office/infopath/2007/PartnerControls"/>
    <ds:schemaRef ds:uri="http://schemas.openxmlformats.org/package/2006/metadata/core-properties"/>
    <ds:schemaRef ds:uri="http://schemas.microsoft.com/office/2006/metadata/propertie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98</TotalTime>
  <Words>57</Words>
  <Application>Microsoft Macintosh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ELVIRA GARZA GONZALEZ</dc:creator>
  <cp:lastModifiedBy>Eduardo Rodriguez Noriega</cp:lastModifiedBy>
  <cp:revision>3</cp:revision>
  <dcterms:created xsi:type="dcterms:W3CDTF">2022-05-07T16:52:07Z</dcterms:created>
  <dcterms:modified xsi:type="dcterms:W3CDTF">2022-05-12T16:51:1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CDBBC957D690D41A117A590358041D8</vt:lpwstr>
  </property>
</Properties>
</file>